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57" r:id="rId2"/>
  </p:sldIdLst>
  <p:sldSz cx="13208000" cy="9906000"/>
  <p:notesSz cx="6858000" cy="9144000"/>
  <p:defaultTextStyle>
    <a:defPPr>
      <a:defRPr lang="pt-BR"/>
    </a:defPPr>
    <a:lvl1pPr marL="0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1pPr>
    <a:lvl2pPr marL="278526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2pPr>
    <a:lvl3pPr marL="557052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3pPr>
    <a:lvl4pPr marL="835579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4pPr>
    <a:lvl5pPr marL="1114105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5pPr>
    <a:lvl6pPr marL="1392631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6pPr>
    <a:lvl7pPr marL="1671157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7pPr>
    <a:lvl8pPr marL="1949684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8pPr>
    <a:lvl9pPr marL="2228210" algn="l" defTabSz="557052" rtl="0" eaLnBrk="1" latinLnBrk="0" hangingPunct="1">
      <a:defRPr sz="109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4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78" autoAdjust="0"/>
    <p:restoredTop sz="94660"/>
  </p:normalViewPr>
  <p:slideViewPr>
    <p:cSldViewPr snapToGrid="0">
      <p:cViewPr>
        <p:scale>
          <a:sx n="95" d="100"/>
          <a:sy n="95" d="100"/>
        </p:scale>
        <p:origin x="-1368" y="-78"/>
      </p:cViewPr>
      <p:guideLst>
        <p:guide orient="horz" pos="3120"/>
        <p:guide pos="4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091152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335612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672057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4005084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947579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715280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111493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969113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839738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526738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905822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5AE44-D3BF-41AA-ADA1-EB8E704F9CBF}" type="datetimeFigureOut">
              <a:rPr lang="pt-BR" smtClean="0"/>
              <a:pPr/>
              <a:t>07/06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661E3-D6FC-41F3-AA07-8E03AB99D308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52080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upo 69"/>
          <p:cNvGrpSpPr/>
          <p:nvPr/>
        </p:nvGrpSpPr>
        <p:grpSpPr>
          <a:xfrm>
            <a:off x="2056420" y="218366"/>
            <a:ext cx="9307571" cy="9359636"/>
            <a:chOff x="2056420" y="218366"/>
            <a:chExt cx="9307571" cy="9359636"/>
          </a:xfrm>
        </p:grpSpPr>
        <p:grpSp>
          <p:nvGrpSpPr>
            <p:cNvPr id="16" name="Grupo 15"/>
            <p:cNvGrpSpPr/>
            <p:nvPr/>
          </p:nvGrpSpPr>
          <p:grpSpPr>
            <a:xfrm>
              <a:off x="2176402" y="6190091"/>
              <a:ext cx="9187589" cy="3387911"/>
              <a:chOff x="2176402" y="6190091"/>
              <a:chExt cx="9187589" cy="3387911"/>
            </a:xfrm>
          </p:grpSpPr>
          <p:sp>
            <p:nvSpPr>
              <p:cNvPr id="147" name="CaixaDeTexto 146"/>
              <p:cNvSpPr txBox="1"/>
              <p:nvPr/>
            </p:nvSpPr>
            <p:spPr>
              <a:xfrm>
                <a:off x="2557405" y="7269678"/>
                <a:ext cx="8806586" cy="230832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txBody>
              <a:bodyPr wrap="square" rtlCol="0">
                <a:spAutoFit/>
              </a:bodyPr>
              <a:lstStyle/>
              <a:p>
                <a:r>
                  <a:rPr lang="pt-BR" sz="120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5´ATGAACCATACTCGCTCTGTGATGGAGGCGGTTCTCGCCGTCATCACGTATAGCTTCTGCAGCGTGAGCATGATTCTCGTGAACAAGCTAATCATGAACACGTACGACATGAACTTCCCATTCGGAATCTTGGTGCTGCAGACAGGTGGTGCACTAGTGATTGTGGCGCTGGCGAAGGCAGCTCGCTTCATTGAGTACCCGGCCTTTTCATTCGACGTGGCGAAAAAGTGGCTTCCTCTTACTCTGCTCTTTGTGGCAATGCTGTTCACATCCATGAAGAGCTTGGGCACGATGTCCGTCGCGGCTCAGACGATTCTCAAGAATCTGGCCGTTGTCTTGATCGCACTCGGCGACAAATTCCTCTACGGCAAGGCGCAAACCCCGATGGTCTACTTTTCTTTTGCGTTGATGATCCTCGGCAGCTTGC</a:t>
                </a:r>
                <a:r>
                  <a:rPr lang="pt-BR" sz="1200" b="1" u="sng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TGGCGCCAAGG</a:t>
                </a:r>
                <a:r>
                  <a:rPr lang="pt-BR" sz="1200" b="1" u="sng" dirty="0" smtClean="0">
                    <a:solidFill>
                      <a:srgbClr val="00B0F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CGATAAGTGGGTAACA</a:t>
                </a:r>
                <a:r>
                  <a:rPr lang="en-US" sz="1200" b="1" u="sng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TAGATAG</a:t>
                </a:r>
                <a:r>
                  <a:rPr lang="en-US" sz="1200" b="1" u="sng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TAG</a:t>
                </a:r>
                <a:r>
                  <a:rPr lang="pt-BR" sz="1200" b="1" u="sng" dirty="0" smtClean="0">
                    <a:solidFill>
                      <a:srgbClr val="00B0F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CG</a:t>
                </a:r>
                <a:r>
                  <a:rPr lang="pt-BR" sz="1200" b="1" u="sng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GGGTCTGGTCTGGACGTTTCTTAAC</a:t>
                </a:r>
                <a:r>
                  <a:rPr lang="pt-BR" sz="120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TTGTCTCCACCGTCTCGTACACGCTGTACATGAAGGCTGTCCTTGGCTCTGTCAGTAACTCGATCGGCCGCTACGGTCCTGTCTTCTACAACAACTTGCTGTCCCTGCCCTTTTTCCTGATAATGGGTGTCGGTGACATCATGCCGTTCTCGGCAGCAATCGGTGACACAATCATGTTTGGCAAGCTGGTGCTAACGTTCTCGGTGCTGGTGAGCTCCGTGATGACGTTCTCCGTCTTTTGGTGCATGTCTATAACCTCGCCCACCACAATGAGCGTCGTAGGCTCACTGAACAAGATACCCCTCACCTTTCTGGGCATGCTTGTGTTCCACCAGTTTCCCACTGCAACGGGTTATCTGGGCATCATGATCGCGCTATCCGCAGGCTTCCTATACACGCACCTCAACATCAGGGCGAACCGCGCCAAGGCTTCTTCCGATACGGAGCACCAGATGCAGCAGGCCGGCAAGACGACAGCGGAGTCGATCGTGCTGGTGCGCGCGGACGAGAACAGCAATGACACCTCCAAATCTGAGTAG 3´</a:t>
                </a:r>
                <a:endParaRPr lang="pt-BR" sz="12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159" name="Conector reto 158"/>
              <p:cNvCxnSpPr/>
              <p:nvPr/>
            </p:nvCxnSpPr>
            <p:spPr>
              <a:xfrm flipH="1" flipV="1">
                <a:off x="5712295" y="6195273"/>
                <a:ext cx="2046194" cy="1071972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Conector reto 159"/>
              <p:cNvCxnSpPr/>
              <p:nvPr/>
            </p:nvCxnSpPr>
            <p:spPr>
              <a:xfrm flipH="1" flipV="1">
                <a:off x="5909066" y="6190091"/>
                <a:ext cx="1849423" cy="1077154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Conector reto 175"/>
              <p:cNvCxnSpPr/>
              <p:nvPr/>
            </p:nvCxnSpPr>
            <p:spPr>
              <a:xfrm flipH="1">
                <a:off x="7758489" y="6192348"/>
                <a:ext cx="1846444" cy="1074897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Conector reto 177"/>
              <p:cNvCxnSpPr/>
              <p:nvPr/>
            </p:nvCxnSpPr>
            <p:spPr>
              <a:xfrm flipV="1">
                <a:off x="7763415" y="6199227"/>
                <a:ext cx="2043131" cy="1068018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3" name="CaixaDeTexto 182"/>
              <p:cNvSpPr txBox="1"/>
              <p:nvPr/>
            </p:nvSpPr>
            <p:spPr>
              <a:xfrm>
                <a:off x="2176402" y="6807667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pic>
          <p:nvPicPr>
            <p:cNvPr id="146" name="Imagem 145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057768" y="4147072"/>
              <a:ext cx="8806586" cy="543014"/>
            </a:xfrm>
            <a:prstGeom prst="rect">
              <a:avLst/>
            </a:prstGeom>
          </p:spPr>
        </p:pic>
        <p:cxnSp>
          <p:nvCxnSpPr>
            <p:cNvPr id="149" name="Conector reto 148"/>
            <p:cNvCxnSpPr/>
            <p:nvPr/>
          </p:nvCxnSpPr>
          <p:spPr>
            <a:xfrm flipV="1">
              <a:off x="2972168" y="3804951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ector reto 149"/>
            <p:cNvCxnSpPr/>
            <p:nvPr/>
          </p:nvCxnSpPr>
          <p:spPr>
            <a:xfrm flipV="1">
              <a:off x="5905868" y="3804951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ector reto 150"/>
            <p:cNvCxnSpPr/>
            <p:nvPr/>
          </p:nvCxnSpPr>
          <p:spPr>
            <a:xfrm>
              <a:off x="2972168" y="3804951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Retângulo 151"/>
            <p:cNvSpPr/>
            <p:nvPr/>
          </p:nvSpPr>
          <p:spPr>
            <a:xfrm>
              <a:off x="3968691" y="3673393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4" name="Conector reto 153"/>
            <p:cNvCxnSpPr/>
            <p:nvPr/>
          </p:nvCxnSpPr>
          <p:spPr>
            <a:xfrm flipV="1">
              <a:off x="6870065" y="3808082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ector reto 154"/>
            <p:cNvCxnSpPr/>
            <p:nvPr/>
          </p:nvCxnSpPr>
          <p:spPr>
            <a:xfrm flipV="1">
              <a:off x="9803765" y="3808082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ector reto 155"/>
            <p:cNvCxnSpPr/>
            <p:nvPr/>
          </p:nvCxnSpPr>
          <p:spPr>
            <a:xfrm>
              <a:off x="6870065" y="3808082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tângulo 156"/>
            <p:cNvSpPr/>
            <p:nvPr/>
          </p:nvSpPr>
          <p:spPr>
            <a:xfrm>
              <a:off x="7866588" y="3676524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CaixaDeTexto 157"/>
            <p:cNvSpPr txBox="1"/>
            <p:nvPr/>
          </p:nvSpPr>
          <p:spPr>
            <a:xfrm>
              <a:off x="10139079" y="4972107"/>
              <a:ext cx="1128835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nockout</a:t>
              </a:r>
            </a:p>
            <a:p>
              <a:pPr algn="ctr"/>
              <a:r>
                <a:rPr lang="pt-B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2n)</a:t>
              </a:r>
              <a:endParaRPr lang="pt-BR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1" name="Imagem 160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123061" y="2290693"/>
              <a:ext cx="8806586" cy="543014"/>
            </a:xfrm>
            <a:prstGeom prst="rect">
              <a:avLst/>
            </a:prstGeom>
          </p:spPr>
        </p:pic>
        <p:cxnSp>
          <p:nvCxnSpPr>
            <p:cNvPr id="163" name="Conector reto 162"/>
            <p:cNvCxnSpPr/>
            <p:nvPr/>
          </p:nvCxnSpPr>
          <p:spPr>
            <a:xfrm flipV="1">
              <a:off x="3037461" y="1948572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ector reto 163"/>
            <p:cNvCxnSpPr/>
            <p:nvPr/>
          </p:nvCxnSpPr>
          <p:spPr>
            <a:xfrm flipV="1">
              <a:off x="5971161" y="1948572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ector reto 164"/>
            <p:cNvCxnSpPr/>
            <p:nvPr/>
          </p:nvCxnSpPr>
          <p:spPr>
            <a:xfrm>
              <a:off x="3037461" y="1948572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Retângulo 165"/>
            <p:cNvSpPr/>
            <p:nvPr/>
          </p:nvSpPr>
          <p:spPr>
            <a:xfrm>
              <a:off x="4033984" y="1817014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8" name="Conector reto 167"/>
            <p:cNvCxnSpPr/>
            <p:nvPr/>
          </p:nvCxnSpPr>
          <p:spPr>
            <a:xfrm flipV="1">
              <a:off x="6935358" y="1951703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ector reto 168"/>
            <p:cNvCxnSpPr/>
            <p:nvPr/>
          </p:nvCxnSpPr>
          <p:spPr>
            <a:xfrm flipV="1">
              <a:off x="9869058" y="1951703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ector reto 169"/>
            <p:cNvCxnSpPr/>
            <p:nvPr/>
          </p:nvCxnSpPr>
          <p:spPr>
            <a:xfrm>
              <a:off x="6935358" y="1951703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Retângulo 170"/>
            <p:cNvSpPr/>
            <p:nvPr/>
          </p:nvSpPr>
          <p:spPr>
            <a:xfrm>
              <a:off x="7931881" y="1820145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CaixaDeTexto 171"/>
            <p:cNvSpPr txBox="1"/>
            <p:nvPr/>
          </p:nvSpPr>
          <p:spPr>
            <a:xfrm>
              <a:off x="9496499" y="2837519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CaixaDeTexto 172"/>
            <p:cNvSpPr txBox="1"/>
            <p:nvPr/>
          </p:nvSpPr>
          <p:spPr>
            <a:xfrm>
              <a:off x="5581547" y="2843912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CaixaDeTexto 173"/>
            <p:cNvSpPr txBox="1"/>
            <p:nvPr/>
          </p:nvSpPr>
          <p:spPr>
            <a:xfrm>
              <a:off x="2176402" y="21836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pt-BR" sz="1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CaixaDeTexto 174"/>
            <p:cNvSpPr txBox="1"/>
            <p:nvPr/>
          </p:nvSpPr>
          <p:spPr>
            <a:xfrm>
              <a:off x="2176402" y="352926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pt-BR" sz="1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4" name="Conector reto 183"/>
            <p:cNvCxnSpPr/>
            <p:nvPr/>
          </p:nvCxnSpPr>
          <p:spPr>
            <a:xfrm>
              <a:off x="5813278" y="4147072"/>
              <a:ext cx="0" cy="53265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5" name="Imagem 184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123059" y="775658"/>
              <a:ext cx="8806586" cy="543014"/>
            </a:xfrm>
            <a:prstGeom prst="rect">
              <a:avLst/>
            </a:prstGeom>
          </p:spPr>
        </p:pic>
        <p:cxnSp>
          <p:nvCxnSpPr>
            <p:cNvPr id="187" name="Conector reto 186"/>
            <p:cNvCxnSpPr/>
            <p:nvPr/>
          </p:nvCxnSpPr>
          <p:spPr>
            <a:xfrm flipV="1">
              <a:off x="3037459" y="433537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Conector reto 187"/>
            <p:cNvCxnSpPr/>
            <p:nvPr/>
          </p:nvCxnSpPr>
          <p:spPr>
            <a:xfrm flipV="1">
              <a:off x="5971159" y="433537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Conector reto 188"/>
            <p:cNvCxnSpPr/>
            <p:nvPr/>
          </p:nvCxnSpPr>
          <p:spPr>
            <a:xfrm>
              <a:off x="3037459" y="433537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Retângulo 189"/>
            <p:cNvSpPr/>
            <p:nvPr/>
          </p:nvSpPr>
          <p:spPr>
            <a:xfrm>
              <a:off x="4033982" y="301979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2" name="Conector reto 191"/>
            <p:cNvCxnSpPr/>
            <p:nvPr/>
          </p:nvCxnSpPr>
          <p:spPr>
            <a:xfrm flipV="1">
              <a:off x="6935356" y="436668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ector reto 194"/>
            <p:cNvCxnSpPr/>
            <p:nvPr/>
          </p:nvCxnSpPr>
          <p:spPr>
            <a:xfrm flipV="1">
              <a:off x="9869056" y="436668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ector reto 195"/>
            <p:cNvCxnSpPr/>
            <p:nvPr/>
          </p:nvCxnSpPr>
          <p:spPr>
            <a:xfrm>
              <a:off x="6935356" y="436668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Retângulo 196"/>
            <p:cNvSpPr/>
            <p:nvPr/>
          </p:nvSpPr>
          <p:spPr>
            <a:xfrm>
              <a:off x="7931879" y="305110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CaixaDeTexto 197"/>
            <p:cNvSpPr txBox="1"/>
            <p:nvPr/>
          </p:nvSpPr>
          <p:spPr>
            <a:xfrm>
              <a:off x="10139079" y="1578941"/>
              <a:ext cx="110780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ld-</a:t>
              </a:r>
              <a:r>
                <a:rPr lang="pt-B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ype</a:t>
              </a:r>
              <a:endParaRPr lang="pt-BR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pt-B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2n)</a:t>
              </a:r>
              <a:endParaRPr lang="pt-BR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0" name="Imagem 199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056420" y="5658928"/>
              <a:ext cx="8806586" cy="543014"/>
            </a:xfrm>
            <a:prstGeom prst="rect">
              <a:avLst/>
            </a:prstGeom>
          </p:spPr>
        </p:pic>
        <p:cxnSp>
          <p:nvCxnSpPr>
            <p:cNvPr id="214" name="Conector reto 213"/>
            <p:cNvCxnSpPr/>
            <p:nvPr/>
          </p:nvCxnSpPr>
          <p:spPr>
            <a:xfrm flipV="1">
              <a:off x="2970820" y="5316807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ector reto 215"/>
            <p:cNvCxnSpPr/>
            <p:nvPr/>
          </p:nvCxnSpPr>
          <p:spPr>
            <a:xfrm flipV="1">
              <a:off x="5904520" y="5316807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Conector reto 216"/>
            <p:cNvCxnSpPr/>
            <p:nvPr/>
          </p:nvCxnSpPr>
          <p:spPr>
            <a:xfrm>
              <a:off x="2970820" y="5316807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9" name="Retângulo 228"/>
            <p:cNvSpPr/>
            <p:nvPr/>
          </p:nvSpPr>
          <p:spPr>
            <a:xfrm>
              <a:off x="3967343" y="5185249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1" name="Conector reto 230"/>
            <p:cNvCxnSpPr/>
            <p:nvPr/>
          </p:nvCxnSpPr>
          <p:spPr>
            <a:xfrm flipV="1">
              <a:off x="6868717" y="5319938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ector reto 231"/>
            <p:cNvCxnSpPr/>
            <p:nvPr/>
          </p:nvCxnSpPr>
          <p:spPr>
            <a:xfrm flipV="1">
              <a:off x="9802417" y="5319938"/>
              <a:ext cx="0" cy="24192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ector reto 232"/>
            <p:cNvCxnSpPr/>
            <p:nvPr/>
          </p:nvCxnSpPr>
          <p:spPr>
            <a:xfrm>
              <a:off x="6868717" y="5319938"/>
              <a:ext cx="2936940" cy="0"/>
            </a:xfrm>
            <a:prstGeom prst="line">
              <a:avLst/>
            </a:prstGeom>
            <a:ln w="158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Retângulo 233"/>
            <p:cNvSpPr/>
            <p:nvPr/>
          </p:nvSpPr>
          <p:spPr>
            <a:xfrm>
              <a:off x="7865240" y="5188380"/>
              <a:ext cx="940654" cy="2603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ray</a:t>
              </a:r>
              <a:r>
                <a:rPr lang="pt-BR" sz="1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pt-BR" sz="1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5" name="Conector reto 234"/>
            <p:cNvCxnSpPr/>
            <p:nvPr/>
          </p:nvCxnSpPr>
          <p:spPr>
            <a:xfrm>
              <a:off x="5811930" y="5658928"/>
              <a:ext cx="0" cy="53265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ector reto 235"/>
            <p:cNvCxnSpPr/>
            <p:nvPr/>
          </p:nvCxnSpPr>
          <p:spPr>
            <a:xfrm>
              <a:off x="9699626" y="4151865"/>
              <a:ext cx="0" cy="53265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Conector reto 236"/>
            <p:cNvCxnSpPr/>
            <p:nvPr/>
          </p:nvCxnSpPr>
          <p:spPr>
            <a:xfrm>
              <a:off x="9696365" y="5658928"/>
              <a:ext cx="0" cy="53265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CaixaDeTexto 56"/>
            <p:cNvSpPr txBox="1"/>
            <p:nvPr/>
          </p:nvSpPr>
          <p:spPr>
            <a:xfrm>
              <a:off x="5581547" y="1331757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9496499" y="1341430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5581547" y="4711082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9496499" y="4720755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5581547" y="6168207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9496499" y="6177880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G2</a:t>
              </a:r>
              <a:endParaRPr lang="pt-B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Conector de seta reta 3"/>
            <p:cNvCxnSpPr/>
            <p:nvPr/>
          </p:nvCxnSpPr>
          <p:spPr>
            <a:xfrm>
              <a:off x="5655531" y="4101455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ector de seta reta 71"/>
            <p:cNvCxnSpPr/>
            <p:nvPr/>
          </p:nvCxnSpPr>
          <p:spPr>
            <a:xfrm rot="10800000">
              <a:off x="5816950" y="4101455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ector de seta reta 72"/>
            <p:cNvCxnSpPr/>
            <p:nvPr/>
          </p:nvCxnSpPr>
          <p:spPr>
            <a:xfrm>
              <a:off x="5649592" y="5606227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ector de seta reta 73"/>
            <p:cNvCxnSpPr/>
            <p:nvPr/>
          </p:nvCxnSpPr>
          <p:spPr>
            <a:xfrm rot="10800000">
              <a:off x="5811011" y="5606227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ector de seta reta 80"/>
            <p:cNvCxnSpPr/>
            <p:nvPr/>
          </p:nvCxnSpPr>
          <p:spPr>
            <a:xfrm>
              <a:off x="9534947" y="4097354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ector de seta reta 81"/>
            <p:cNvCxnSpPr/>
            <p:nvPr/>
          </p:nvCxnSpPr>
          <p:spPr>
            <a:xfrm rot="10800000">
              <a:off x="9696366" y="4097354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ector de seta reta 82"/>
            <p:cNvCxnSpPr/>
            <p:nvPr/>
          </p:nvCxnSpPr>
          <p:spPr>
            <a:xfrm>
              <a:off x="9533676" y="5602154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ector de seta reta 83"/>
            <p:cNvCxnSpPr/>
            <p:nvPr/>
          </p:nvCxnSpPr>
          <p:spPr>
            <a:xfrm rot="10800000">
              <a:off x="9695095" y="5602154"/>
              <a:ext cx="160148" cy="23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763065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3</TotalTime>
  <Words>40</Words>
  <Application>Microsoft Office PowerPoint</Application>
  <PresentationFormat>Personalizar</PresentationFormat>
  <Paragraphs>2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Flávio Henrique de Jesus Santos</dc:creator>
  <cp:lastModifiedBy>Leonardo Paiva Farias</cp:lastModifiedBy>
  <cp:revision>48</cp:revision>
  <dcterms:created xsi:type="dcterms:W3CDTF">2020-03-09T19:34:05Z</dcterms:created>
  <dcterms:modified xsi:type="dcterms:W3CDTF">2020-06-07T04:26:18Z</dcterms:modified>
</cp:coreProperties>
</file>